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3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5" r:id="rId3"/>
    <p:sldId id="273" r:id="rId4"/>
    <p:sldId id="260" r:id="rId5"/>
    <p:sldId id="267" r:id="rId6"/>
    <p:sldId id="258" r:id="rId7"/>
    <p:sldId id="268" r:id="rId8"/>
    <p:sldId id="270" r:id="rId9"/>
    <p:sldId id="271" r:id="rId10"/>
    <p:sldId id="269" r:id="rId11"/>
    <p:sldId id="272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4" userDrawn="1">
          <p15:clr>
            <a:srgbClr val="A4A3A4"/>
          </p15:clr>
        </p15:guide>
        <p15:guide id="2" pos="18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8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00" y="96"/>
      </p:cViewPr>
      <p:guideLst>
        <p:guide orient="horz" pos="3144"/>
        <p:guide pos="18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2022\Paper\GMK1%20&#51076;&#51333;&#55148;\Gene%20expression\PRJNA285880\JW4082ds.expression.tpm_S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jhim\Documents\&#53097;\ROS\ROS%20and%20gene%20expression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per\Desktop\&#53685;&#54633;%20&#47928;&#49436;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per\Desktop\&#53685;&#54633;%20&#47928;&#49436;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jhim\Documents\&#53097;\ROS\ROS%20and%20gene%20expression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jhim\Documents\&#53097;\ROS\Gm_H2O2.xls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jhim\Documents\&#53097;\ROS\ROS%20and%20gene%20expressio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JW4082ds.expression.tpm_ST (3)'!$E$2</c:f>
              <c:strCache>
                <c:ptCount val="1"/>
                <c:pt idx="0">
                  <c:v>Rati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FF3-42B8-AA85-CE878F3ECDF4}"/>
              </c:ext>
            </c:extLst>
          </c:dPt>
          <c:cat>
            <c:strRef>
              <c:f>'JW4082ds.expression.tpm_ST (3)'!$D$3:$D$19</c:f>
              <c:strCache>
                <c:ptCount val="17"/>
                <c:pt idx="0">
                  <c:v>GmRbohD2</c:v>
                </c:pt>
                <c:pt idx="1">
                  <c:v>GmRbohD1</c:v>
                </c:pt>
                <c:pt idx="2">
                  <c:v>GmRbohH2</c:v>
                </c:pt>
                <c:pt idx="3">
                  <c:v>GmRbohH1</c:v>
                </c:pt>
                <c:pt idx="4">
                  <c:v>GmRbohG</c:v>
                </c:pt>
                <c:pt idx="5">
                  <c:v>GmRbohF2</c:v>
                </c:pt>
                <c:pt idx="6">
                  <c:v>GmRbohF1</c:v>
                </c:pt>
                <c:pt idx="7">
                  <c:v>GmRbohA2</c:v>
                </c:pt>
                <c:pt idx="8">
                  <c:v>GmRbohA1</c:v>
                </c:pt>
                <c:pt idx="9">
                  <c:v>GmRbohI2</c:v>
                </c:pt>
                <c:pt idx="10">
                  <c:v>GmRbohI1</c:v>
                </c:pt>
                <c:pt idx="11">
                  <c:v>GmRbohB2</c:v>
                </c:pt>
                <c:pt idx="12">
                  <c:v>GmRbohB1</c:v>
                </c:pt>
                <c:pt idx="13">
                  <c:v>GmRbohE2</c:v>
                </c:pt>
                <c:pt idx="14">
                  <c:v>GmRbohE1</c:v>
                </c:pt>
                <c:pt idx="15">
                  <c:v>GmRbohC2</c:v>
                </c:pt>
                <c:pt idx="16">
                  <c:v>GmRbohC1</c:v>
                </c:pt>
              </c:strCache>
            </c:strRef>
          </c:cat>
          <c:val>
            <c:numRef>
              <c:f>'JW4082ds.expression.tpm_ST (3)'!$E$3:$E$19</c:f>
              <c:numCache>
                <c:formatCode>0.0</c:formatCode>
                <c:ptCount val="17"/>
                <c:pt idx="0">
                  <c:v>2.125558404457891</c:v>
                </c:pt>
                <c:pt idx="1">
                  <c:v>2.1657380865784321</c:v>
                </c:pt>
                <c:pt idx="2">
                  <c:v>0.13581240583238041</c:v>
                </c:pt>
                <c:pt idx="3">
                  <c:v>3.183133903133903</c:v>
                </c:pt>
                <c:pt idx="4">
                  <c:v>0</c:v>
                </c:pt>
                <c:pt idx="5">
                  <c:v>1.7004715089669666</c:v>
                </c:pt>
                <c:pt idx="6">
                  <c:v>0.98868551539674043</c:v>
                </c:pt>
                <c:pt idx="7">
                  <c:v>0.63632977063234963</c:v>
                </c:pt>
                <c:pt idx="8">
                  <c:v>0.50434378218359543</c:v>
                </c:pt>
                <c:pt idx="9">
                  <c:v>3.5339214309197935</c:v>
                </c:pt>
                <c:pt idx="10">
                  <c:v>4.6037364058656687</c:v>
                </c:pt>
                <c:pt idx="11">
                  <c:v>3.1335081089133832</c:v>
                </c:pt>
                <c:pt idx="12">
                  <c:v>3.4953512402369458</c:v>
                </c:pt>
                <c:pt idx="13">
                  <c:v>0.50092129664715079</c:v>
                </c:pt>
                <c:pt idx="14">
                  <c:v>0.53715499121033194</c:v>
                </c:pt>
                <c:pt idx="15">
                  <c:v>1.3100814693487104</c:v>
                </c:pt>
                <c:pt idx="16">
                  <c:v>1.29629995238754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FF3-42B8-AA85-CE878F3ECD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40433472"/>
        <c:axId val="184355744"/>
      </c:barChart>
      <c:catAx>
        <c:axId val="24043347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84355744"/>
        <c:crosses val="autoZero"/>
        <c:auto val="1"/>
        <c:lblAlgn val="ctr"/>
        <c:lblOffset val="100"/>
        <c:noMultiLvlLbl val="0"/>
      </c:catAx>
      <c:valAx>
        <c:axId val="1843557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0433472"/>
        <c:crosses val="autoZero"/>
        <c:crossBetween val="between"/>
        <c:majorUnit val="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548277851148965"/>
          <c:y val="4.1428259865551396E-2"/>
          <c:w val="0.83550043437925869"/>
          <c:h val="0.67832561451223894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D$1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11:$T$11</c:f>
                <c:numCache>
                  <c:formatCode>General</c:formatCode>
                  <c:ptCount val="7"/>
                  <c:pt idx="0">
                    <c:v>0.18</c:v>
                  </c:pt>
                  <c:pt idx="1">
                    <c:v>0.24</c:v>
                  </c:pt>
                  <c:pt idx="2">
                    <c:v>0.85</c:v>
                  </c:pt>
                  <c:pt idx="3">
                    <c:v>0.69</c:v>
                  </c:pt>
                  <c:pt idx="4">
                    <c:v>0.42</c:v>
                  </c:pt>
                  <c:pt idx="5">
                    <c:v>0.75</c:v>
                  </c:pt>
                  <c:pt idx="6">
                    <c:v>1.36</c:v>
                  </c:pt>
                </c:numCache>
              </c:numRef>
            </c:plus>
            <c:minus>
              <c:numRef>
                <c:f>Sheet2!$N$11:$T$11</c:f>
                <c:numCache>
                  <c:formatCode>General</c:formatCode>
                  <c:ptCount val="7"/>
                  <c:pt idx="0">
                    <c:v>0.18</c:v>
                  </c:pt>
                  <c:pt idx="1">
                    <c:v>0.24</c:v>
                  </c:pt>
                  <c:pt idx="2">
                    <c:v>0.85</c:v>
                  </c:pt>
                  <c:pt idx="3">
                    <c:v>0.69</c:v>
                  </c:pt>
                  <c:pt idx="4">
                    <c:v>0.42</c:v>
                  </c:pt>
                  <c:pt idx="5">
                    <c:v>0.75</c:v>
                  </c:pt>
                  <c:pt idx="6">
                    <c:v>1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2!$E$11:$K$11</c:f>
              <c:numCache>
                <c:formatCode>General</c:formatCode>
                <c:ptCount val="7"/>
                <c:pt idx="0">
                  <c:v>1.1399999999999999</c:v>
                </c:pt>
                <c:pt idx="1">
                  <c:v>3.85</c:v>
                </c:pt>
                <c:pt idx="2">
                  <c:v>6.57</c:v>
                </c:pt>
                <c:pt idx="3">
                  <c:v>8.34</c:v>
                </c:pt>
                <c:pt idx="4">
                  <c:v>12.56</c:v>
                </c:pt>
                <c:pt idx="5">
                  <c:v>14.42</c:v>
                </c:pt>
                <c:pt idx="6">
                  <c:v>3.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87-400D-8EDC-E05DDBC085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873231"/>
        <c:axId val="1751869487"/>
      </c:barChart>
      <c:catAx>
        <c:axId val="17518732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69487"/>
        <c:crosses val="autoZero"/>
        <c:auto val="1"/>
        <c:lblAlgn val="ctr"/>
        <c:lblOffset val="100"/>
        <c:noMultiLvlLbl val="0"/>
      </c:catAx>
      <c:valAx>
        <c:axId val="1751869487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73231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7:$G$13</c:f>
                <c:numCache>
                  <c:formatCode>General</c:formatCode>
                  <c:ptCount val="7"/>
                  <c:pt idx="0">
                    <c:v>0.15</c:v>
                  </c:pt>
                  <c:pt idx="1">
                    <c:v>0.57999999999999996</c:v>
                  </c:pt>
                  <c:pt idx="2">
                    <c:v>0.54</c:v>
                  </c:pt>
                  <c:pt idx="3">
                    <c:v>1.28</c:v>
                  </c:pt>
                  <c:pt idx="4">
                    <c:v>0.69</c:v>
                  </c:pt>
                  <c:pt idx="5">
                    <c:v>1.52</c:v>
                  </c:pt>
                  <c:pt idx="6">
                    <c:v>0.28000000000000003</c:v>
                  </c:pt>
                </c:numCache>
              </c:numRef>
            </c:plus>
            <c:minus>
              <c:numRef>
                <c:f>Sheet1!$G$7:$G$13</c:f>
                <c:numCache>
                  <c:formatCode>General</c:formatCode>
                  <c:ptCount val="7"/>
                  <c:pt idx="0">
                    <c:v>0.15</c:v>
                  </c:pt>
                  <c:pt idx="1">
                    <c:v>0.57999999999999996</c:v>
                  </c:pt>
                  <c:pt idx="2">
                    <c:v>0.54</c:v>
                  </c:pt>
                  <c:pt idx="3">
                    <c:v>1.28</c:v>
                  </c:pt>
                  <c:pt idx="4">
                    <c:v>0.69</c:v>
                  </c:pt>
                  <c:pt idx="5">
                    <c:v>1.52</c:v>
                  </c:pt>
                  <c:pt idx="6">
                    <c:v>0.28000000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F$7:$F$13</c:f>
              <c:numCache>
                <c:formatCode>General</c:formatCode>
                <c:ptCount val="7"/>
                <c:pt idx="0">
                  <c:v>0.92</c:v>
                </c:pt>
                <c:pt idx="1">
                  <c:v>4.18</c:v>
                </c:pt>
                <c:pt idx="2">
                  <c:v>6.31</c:v>
                </c:pt>
                <c:pt idx="3">
                  <c:v>7.92</c:v>
                </c:pt>
                <c:pt idx="4">
                  <c:v>11.59</c:v>
                </c:pt>
                <c:pt idx="5">
                  <c:v>13.87</c:v>
                </c:pt>
                <c:pt idx="6">
                  <c:v>3.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F8-44BB-93DF-CAF6535152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0696255"/>
        <c:axId val="1830697503"/>
      </c:barChart>
      <c:catAx>
        <c:axId val="18306962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0697503"/>
        <c:crosses val="autoZero"/>
        <c:auto val="1"/>
        <c:lblAlgn val="ctr"/>
        <c:lblOffset val="100"/>
        <c:noMultiLvlLbl val="0"/>
      </c:catAx>
      <c:valAx>
        <c:axId val="1830697503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0696255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7:$J$13</c:f>
                <c:numCache>
                  <c:formatCode>General</c:formatCode>
                  <c:ptCount val="7"/>
                  <c:pt idx="0">
                    <c:v>0.08</c:v>
                  </c:pt>
                  <c:pt idx="1">
                    <c:v>0.12</c:v>
                  </c:pt>
                  <c:pt idx="2">
                    <c:v>0.39</c:v>
                  </c:pt>
                  <c:pt idx="3">
                    <c:v>0.85</c:v>
                  </c:pt>
                  <c:pt idx="4">
                    <c:v>0.54</c:v>
                  </c:pt>
                  <c:pt idx="5">
                    <c:v>1.1599999999999999</c:v>
                  </c:pt>
                  <c:pt idx="6">
                    <c:v>0.27</c:v>
                  </c:pt>
                </c:numCache>
              </c:numRef>
            </c:plus>
            <c:minus>
              <c:numRef>
                <c:f>Sheet1!$J$7:$J$13</c:f>
                <c:numCache>
                  <c:formatCode>General</c:formatCode>
                  <c:ptCount val="7"/>
                  <c:pt idx="0">
                    <c:v>0.08</c:v>
                  </c:pt>
                  <c:pt idx="1">
                    <c:v>0.12</c:v>
                  </c:pt>
                  <c:pt idx="2">
                    <c:v>0.39</c:v>
                  </c:pt>
                  <c:pt idx="3">
                    <c:v>0.85</c:v>
                  </c:pt>
                  <c:pt idx="4">
                    <c:v>0.54</c:v>
                  </c:pt>
                  <c:pt idx="5">
                    <c:v>1.1599999999999999</c:v>
                  </c:pt>
                  <c:pt idx="6">
                    <c:v>0.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I$7:$I$13</c:f>
              <c:numCache>
                <c:formatCode>General</c:formatCode>
                <c:ptCount val="7"/>
                <c:pt idx="0">
                  <c:v>1.07</c:v>
                </c:pt>
                <c:pt idx="1">
                  <c:v>3.27</c:v>
                </c:pt>
                <c:pt idx="2">
                  <c:v>5.14</c:v>
                </c:pt>
                <c:pt idx="3">
                  <c:v>7.38</c:v>
                </c:pt>
                <c:pt idx="4">
                  <c:v>10.68</c:v>
                </c:pt>
                <c:pt idx="5">
                  <c:v>11.32</c:v>
                </c:pt>
                <c:pt idx="6">
                  <c:v>2.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B2-43A2-AE40-2138071559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21740607"/>
        <c:axId val="1921742687"/>
      </c:barChart>
      <c:catAx>
        <c:axId val="192174060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1742687"/>
        <c:crosses val="autoZero"/>
        <c:auto val="1"/>
        <c:lblAlgn val="ctr"/>
        <c:lblOffset val="100"/>
        <c:noMultiLvlLbl val="0"/>
      </c:catAx>
      <c:valAx>
        <c:axId val="1921742687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1740607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E$6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6:$S$6</c:f>
                <c:numCache>
                  <c:formatCode>General</c:formatCode>
                  <c:ptCount val="6"/>
                  <c:pt idx="0">
                    <c:v>5.0000000000000001E-3</c:v>
                  </c:pt>
                  <c:pt idx="1">
                    <c:v>1.2E-2</c:v>
                  </c:pt>
                  <c:pt idx="2">
                    <c:v>2.5000000000000001E-2</c:v>
                  </c:pt>
                  <c:pt idx="3">
                    <c:v>2.5000000000000001E-2</c:v>
                  </c:pt>
                  <c:pt idx="4">
                    <c:v>5.6000000000000001E-2</c:v>
                  </c:pt>
                  <c:pt idx="5">
                    <c:v>2.5999999999999999E-2</c:v>
                  </c:pt>
                </c:numCache>
              </c:numRef>
            </c:plus>
            <c:minus>
              <c:numRef>
                <c:f>Sheet1!$N$6:$S$6</c:f>
                <c:numCache>
                  <c:formatCode>General</c:formatCode>
                  <c:ptCount val="6"/>
                  <c:pt idx="0">
                    <c:v>5.0000000000000001E-3</c:v>
                  </c:pt>
                  <c:pt idx="1">
                    <c:v>1.2E-2</c:v>
                  </c:pt>
                  <c:pt idx="2">
                    <c:v>2.5000000000000001E-2</c:v>
                  </c:pt>
                  <c:pt idx="3">
                    <c:v>2.5000000000000001E-2</c:v>
                  </c:pt>
                  <c:pt idx="4">
                    <c:v>5.6000000000000001E-2</c:v>
                  </c:pt>
                  <c:pt idx="5">
                    <c:v>2.59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F$6:$K$6</c:f>
              <c:numCache>
                <c:formatCode>General</c:formatCode>
                <c:ptCount val="6"/>
                <c:pt idx="0">
                  <c:v>3.7999999999999999E-2</c:v>
                </c:pt>
                <c:pt idx="1">
                  <c:v>8.4000000000000005E-2</c:v>
                </c:pt>
                <c:pt idx="2">
                  <c:v>0.17499999999999999</c:v>
                </c:pt>
                <c:pt idx="3">
                  <c:v>0.28899999999999998</c:v>
                </c:pt>
                <c:pt idx="4">
                  <c:v>0.35099999999999998</c:v>
                </c:pt>
                <c:pt idx="5">
                  <c:v>0.536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5ED-4E7C-96DB-E47024BEBB23}"/>
            </c:ext>
          </c:extLst>
        </c:ser>
        <c:ser>
          <c:idx val="1"/>
          <c:order val="1"/>
          <c:tx>
            <c:strRef>
              <c:f>Sheet1!$E$7</c:f>
              <c:strCache>
                <c:ptCount val="1"/>
                <c:pt idx="0">
                  <c:v>SB202190</c:v>
                </c:pt>
              </c:strCache>
            </c:strRef>
          </c:tx>
          <c:spPr>
            <a:ln w="28575" cap="rnd">
              <a:solidFill>
                <a:sysClr val="windowText" lastClr="000000">
                  <a:lumMod val="65000"/>
                  <a:lumOff val="35000"/>
                </a:sysClr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ysClr val="windowText" lastClr="000000"/>
              </a:solidFill>
              <a:ln w="9525">
                <a:solidFill>
                  <a:sysClr val="windowText" lastClr="000000">
                    <a:lumMod val="65000"/>
                    <a:lumOff val="35000"/>
                  </a:sys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7:$S$7</c:f>
                <c:numCache>
                  <c:formatCode>General</c:formatCode>
                  <c:ptCount val="6"/>
                  <c:pt idx="0">
                    <c:v>1E-3</c:v>
                  </c:pt>
                  <c:pt idx="1">
                    <c:v>1.2999999999999999E-2</c:v>
                  </c:pt>
                  <c:pt idx="2">
                    <c:v>1.2E-2</c:v>
                  </c:pt>
                  <c:pt idx="3">
                    <c:v>1.2E-2</c:v>
                  </c:pt>
                  <c:pt idx="4">
                    <c:v>2.5000000000000001E-2</c:v>
                  </c:pt>
                  <c:pt idx="5">
                    <c:v>2.5000000000000001E-2</c:v>
                  </c:pt>
                </c:numCache>
              </c:numRef>
            </c:plus>
            <c:minus>
              <c:numRef>
                <c:f>Sheet1!$N$7:$S$7</c:f>
                <c:numCache>
                  <c:formatCode>General</c:formatCode>
                  <c:ptCount val="6"/>
                  <c:pt idx="0">
                    <c:v>1E-3</c:v>
                  </c:pt>
                  <c:pt idx="1">
                    <c:v>1.2999999999999999E-2</c:v>
                  </c:pt>
                  <c:pt idx="2">
                    <c:v>1.2E-2</c:v>
                  </c:pt>
                  <c:pt idx="3">
                    <c:v>1.2E-2</c:v>
                  </c:pt>
                  <c:pt idx="4">
                    <c:v>2.5000000000000001E-2</c:v>
                  </c:pt>
                  <c:pt idx="5">
                    <c:v>2.50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F$7:$K$7</c:f>
              <c:numCache>
                <c:formatCode>General</c:formatCode>
                <c:ptCount val="6"/>
                <c:pt idx="0">
                  <c:v>0.04</c:v>
                </c:pt>
                <c:pt idx="1">
                  <c:v>9.5000000000000001E-2</c:v>
                </c:pt>
                <c:pt idx="2">
                  <c:v>0.115</c:v>
                </c:pt>
                <c:pt idx="3">
                  <c:v>0.16500000000000001</c:v>
                </c:pt>
                <c:pt idx="4">
                  <c:v>0.185</c:v>
                </c:pt>
                <c:pt idx="5">
                  <c:v>0.2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5ED-4E7C-96DB-E47024BEBB23}"/>
            </c:ext>
          </c:extLst>
        </c:ser>
        <c:ser>
          <c:idx val="2"/>
          <c:order val="2"/>
          <c:tx>
            <c:strRef>
              <c:f>Sheet1!$E$8</c:f>
              <c:strCache>
                <c:ptCount val="1"/>
                <c:pt idx="0">
                  <c:v>DPI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x"/>
            <c:size val="5"/>
            <c:spPr>
              <a:solidFill>
                <a:sysClr val="windowText" lastClr="0000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8:$S$8</c:f>
                <c:numCache>
                  <c:formatCode>General</c:formatCode>
                  <c:ptCount val="6"/>
                  <c:pt idx="0">
                    <c:v>0.01</c:v>
                  </c:pt>
                  <c:pt idx="1">
                    <c:v>0.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3.1E-2</c:v>
                  </c:pt>
                  <c:pt idx="5">
                    <c:v>2.1000000000000001E-2</c:v>
                  </c:pt>
                </c:numCache>
              </c:numRef>
            </c:plus>
            <c:minus>
              <c:numRef>
                <c:f>Sheet1!$N$8:$S$8</c:f>
                <c:numCache>
                  <c:formatCode>General</c:formatCode>
                  <c:ptCount val="6"/>
                  <c:pt idx="0">
                    <c:v>0.01</c:v>
                  </c:pt>
                  <c:pt idx="1">
                    <c:v>0.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3.1E-2</c:v>
                  </c:pt>
                  <c:pt idx="5">
                    <c:v>2.10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1!$F$8:$K$8</c:f>
              <c:numCache>
                <c:formatCode>General</c:formatCode>
                <c:ptCount val="6"/>
                <c:pt idx="0">
                  <c:v>4.2000000000000003E-2</c:v>
                </c:pt>
                <c:pt idx="1">
                  <c:v>4.8000000000000001E-2</c:v>
                </c:pt>
                <c:pt idx="2">
                  <c:v>6.5000000000000002E-2</c:v>
                </c:pt>
                <c:pt idx="3">
                  <c:v>7.8E-2</c:v>
                </c:pt>
                <c:pt idx="4">
                  <c:v>9.8000000000000004E-2</c:v>
                </c:pt>
                <c:pt idx="5">
                  <c:v>0.135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5ED-4E7C-96DB-E47024BEBB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9729791"/>
        <c:axId val="1769731871"/>
      </c:lineChart>
      <c:catAx>
        <c:axId val="17697297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9731871"/>
        <c:crosses val="autoZero"/>
        <c:auto val="1"/>
        <c:lblAlgn val="ctr"/>
        <c:lblOffset val="100"/>
        <c:noMultiLvlLbl val="0"/>
      </c:catAx>
      <c:valAx>
        <c:axId val="17697318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9729791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890407432825487"/>
          <c:y val="7.7370674459334765E-2"/>
          <c:w val="0.49361745406824148"/>
          <c:h val="0.215386024766562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Results!$V$3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AC$35:$AF$35</c:f>
                <c:numCache>
                  <c:formatCode>General</c:formatCode>
                  <c:ptCount val="4"/>
                  <c:pt idx="0">
                    <c:v>0.09</c:v>
                  </c:pt>
                  <c:pt idx="1">
                    <c:v>0.32</c:v>
                  </c:pt>
                  <c:pt idx="2">
                    <c:v>0.69</c:v>
                  </c:pt>
                  <c:pt idx="3">
                    <c:v>1.0900000000000001</c:v>
                  </c:pt>
                </c:numCache>
              </c:numRef>
            </c:plus>
            <c:minus>
              <c:numRef>
                <c:f>Results!$AC$35:$AF$35</c:f>
                <c:numCache>
                  <c:formatCode>General</c:formatCode>
                  <c:ptCount val="4"/>
                  <c:pt idx="0">
                    <c:v>0.09</c:v>
                  </c:pt>
                  <c:pt idx="1">
                    <c:v>0.32</c:v>
                  </c:pt>
                  <c:pt idx="2">
                    <c:v>0.69</c:v>
                  </c:pt>
                  <c:pt idx="3">
                    <c:v>1.09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Results!$W$35:$Z$35</c:f>
              <c:numCache>
                <c:formatCode>General</c:formatCode>
                <c:ptCount val="4"/>
                <c:pt idx="0">
                  <c:v>0.97</c:v>
                </c:pt>
                <c:pt idx="1">
                  <c:v>1.75</c:v>
                </c:pt>
                <c:pt idx="2">
                  <c:v>5.36</c:v>
                </c:pt>
                <c:pt idx="3">
                  <c:v>9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84-446D-977C-DDC34EFD43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873231"/>
        <c:axId val="1751869487"/>
      </c:barChart>
      <c:catAx>
        <c:axId val="17518732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69487"/>
        <c:crosses val="autoZero"/>
        <c:auto val="1"/>
        <c:lblAlgn val="ctr"/>
        <c:lblOffset val="100"/>
        <c:noMultiLvlLbl val="0"/>
      </c:catAx>
      <c:valAx>
        <c:axId val="175186948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73231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2!$P$5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ysClr val="window" lastClr="FFFFFF">
                <a:lumMod val="95000"/>
              </a:sys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W$54:$Z$54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24</c:v>
                  </c:pt>
                  <c:pt idx="2">
                    <c:v>0.65</c:v>
                  </c:pt>
                  <c:pt idx="3">
                    <c:v>0.36</c:v>
                  </c:pt>
                </c:numCache>
              </c:numRef>
            </c:plus>
            <c:minus>
              <c:numRef>
                <c:f>Sheet2!$W$54:$Z$54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24</c:v>
                  </c:pt>
                  <c:pt idx="2">
                    <c:v>0.65</c:v>
                  </c:pt>
                  <c:pt idx="3">
                    <c:v>0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1"/>
              <c:pt idx="0">
                <c:v> </c:v>
              </c:pt>
            </c:strLit>
          </c:cat>
          <c:val>
            <c:numRef>
              <c:f>Sheet2!$Q$54:$T$54</c:f>
              <c:numCache>
                <c:formatCode>General</c:formatCode>
                <c:ptCount val="4"/>
                <c:pt idx="0">
                  <c:v>1.1499999999999999</c:v>
                </c:pt>
                <c:pt idx="1">
                  <c:v>1.78</c:v>
                </c:pt>
                <c:pt idx="2">
                  <c:v>3.25</c:v>
                </c:pt>
                <c:pt idx="3">
                  <c:v>5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BE-4142-A784-EC97BA9093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1873231"/>
        <c:axId val="1751869487"/>
      </c:barChart>
      <c:catAx>
        <c:axId val="17518732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69487"/>
        <c:crosses val="autoZero"/>
        <c:auto val="1"/>
        <c:lblAlgn val="ctr"/>
        <c:lblOffset val="100"/>
        <c:noMultiLvlLbl val="0"/>
      </c:catAx>
      <c:valAx>
        <c:axId val="175186948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1873231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126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095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888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06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677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23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754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252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62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787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658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0315C-38E8-489E-95FE-68AC9B6E00D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3A1F4-488C-4816-88F7-70EA3EF51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516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BFF9EF-A065-E4CD-C690-328341E0ACB6}"/>
              </a:ext>
            </a:extLst>
          </p:cNvPr>
          <p:cNvSpPr txBox="1"/>
          <p:nvPr/>
        </p:nvSpPr>
        <p:spPr>
          <a:xfrm>
            <a:off x="242371" y="2084379"/>
            <a:ext cx="6103346" cy="42165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Supplementary data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1. Expression profiles of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boh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genes under the salt condition.</a:t>
            </a:r>
          </a:p>
          <a:p>
            <a:endParaRPr lang="en-US" altLang="ko-KR" sz="1200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2. Gene expression of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bohI1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ith three different reference genes.</a:t>
            </a:r>
            <a:endParaRPr lang="en-US" altLang="ko-KR" sz="1200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endParaRPr lang="en-US" sz="12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.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KK1 phosphorylates and activates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MPKs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i="1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vitro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</a:p>
          <a:p>
            <a:endParaRPr lang="en-US" sz="12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4.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OS generation in soybean seedings by 0.3 M NaCl treatment with or without pretreatment of SB202190 or DPI.</a:t>
            </a:r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endParaRPr lang="en-US" sz="1200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5. 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henotype of soybean leaves co-treated with 150 mM NaCl and various inhibitors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</a:p>
          <a:p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6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xpression of </a:t>
            </a:r>
            <a:r>
              <a:rPr lang="en-US" altLang="ko-KR" sz="1200" i="1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D19A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NaCl or H</a:t>
            </a:r>
            <a:r>
              <a:rPr lang="en-US" altLang="ko-KR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</a:t>
            </a:r>
            <a:r>
              <a:rPr lang="en-US" altLang="ko-KR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ed soybean seedlings.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endParaRPr lang="en-US" sz="1200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1. List of primers in this study.</a:t>
            </a:r>
          </a:p>
          <a:p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l method</a:t>
            </a:r>
          </a:p>
          <a:p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ferences</a:t>
            </a:r>
          </a:p>
          <a:p>
            <a:endParaRPr lang="en-US" sz="1200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bbreviation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7359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B9811E-D04A-4495-A3CB-F52B94121557}"/>
              </a:ext>
            </a:extLst>
          </p:cNvPr>
          <p:cNvSpPr txBox="1"/>
          <p:nvPr/>
        </p:nvSpPr>
        <p:spPr>
          <a:xfrm>
            <a:off x="262512" y="2138700"/>
            <a:ext cx="633297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s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68000" indent="-457200">
              <a:buAutoNum type="arabicPeriod"/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u, J.; Lu, H.; Wan, Q.; Qi, W.; Shao, H. Genome-wide analysis and expression profiling of respiratory burst oxidase homologue gene family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 max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iron. Exp. Bot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19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344-356.</a:t>
            </a:r>
          </a:p>
          <a:p>
            <a:pPr marL="468000" indent="-457200">
              <a:buFontTx/>
              <a:buAutoNum type="arabicPeriod"/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zman, L. M.; Belin, D.; Carson, M. J.; Beckwith, J. O. N. Tight regulation, modulation, and high-level expression by vectors containing the arabinose PBAD promoter.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ol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95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7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4121-4130.</a:t>
            </a:r>
          </a:p>
          <a:p>
            <a:pPr marL="468000" indent="-457200">
              <a:buAutoNum type="arabicPeriod"/>
            </a:pP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6693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998BC4-E451-2C88-FCE3-4BD129DD37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4406" y="2637014"/>
            <a:ext cx="6122108" cy="231598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</a:p>
          <a:p>
            <a:pPr marL="0" indent="0">
              <a:buNone/>
            </a:pP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1200" dirty="0">
                <a:solidFill>
                  <a:srgbClr val="221E1F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PI: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iphenyleneiodonium chloride</a:t>
            </a:r>
          </a:p>
          <a:p>
            <a:pPr marL="0" indent="0">
              <a:buNone/>
            </a:pPr>
            <a:r>
              <a:rPr lang="en-US" sz="1200" dirty="0">
                <a:solidFill>
                  <a:srgbClr val="221E1F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PK: Mitogen-activated protein kinase</a:t>
            </a:r>
          </a:p>
          <a:p>
            <a:pPr marL="0" indent="0">
              <a:buNone/>
            </a:pP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o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solidFill>
                  <a:srgbClr val="221E1F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piratory burst oxidase homolog</a:t>
            </a:r>
          </a:p>
          <a:p>
            <a:pPr marL="0" indent="0"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S: Reactive Oxygen Species</a:t>
            </a:r>
          </a:p>
          <a:p>
            <a:pPr marL="0" indent="0">
              <a:buNone/>
            </a:pPr>
            <a:r>
              <a:rPr lang="en-US" sz="1200" dirty="0">
                <a:solidFill>
                  <a:srgbClr val="221E1F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XTT: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,3-bis-(2-methoxy-4-nitro-5-sulfophenyl)-2H-tetrazolium-5-carboxanilide</a:t>
            </a:r>
            <a:endParaRPr lang="en-US" sz="1200" dirty="0">
              <a:solidFill>
                <a:srgbClr val="221E1F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0498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직사각형 13">
            <a:extLst>
              <a:ext uri="{FF2B5EF4-FFF2-40B4-BE49-F238E27FC236}">
                <a16:creationId xmlns:a16="http://schemas.microsoft.com/office/drawing/2014/main" id="{F1D86E82-A149-E653-7D3B-B0614016CCD0}"/>
              </a:ext>
            </a:extLst>
          </p:cNvPr>
          <p:cNvSpPr/>
          <p:nvPr/>
        </p:nvSpPr>
        <p:spPr>
          <a:xfrm>
            <a:off x="368929" y="7349826"/>
            <a:ext cx="612014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1. Expression profiles of </a:t>
            </a:r>
            <a:r>
              <a:rPr lang="en-US" altLang="ko-KR" sz="1200" i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boh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genes under the salt condition. (A) The X-axis means the ratio of the TPM value of the salt condition to the TPM value of the control condition. All the data were retrieved from </a:t>
            </a:r>
            <a:r>
              <a:rPr lang="en-US" altLang="ko-KR" sz="1200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iosamples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AMN03761653 for salt treatment and SAMN03761649 for the control from NCBI </a:t>
            </a:r>
            <a:r>
              <a:rPr lang="en-US" altLang="ko-KR" sz="1200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ioproject</a:t>
            </a:r>
            <a:r>
              <a:rPr lang="en-US" altLang="ko-KR" sz="1200" kern="100" dirty="0">
                <a:solidFill>
                  <a:prstClr val="black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RJNA285880. Genes were grouped based on the phylogenetic classification of Liu et al. [1]. </a:t>
            </a:r>
          </a:p>
        </p:txBody>
      </p:sp>
      <p:graphicFrame>
        <p:nvGraphicFramePr>
          <p:cNvPr id="2" name="차트 3">
            <a:extLst>
              <a:ext uri="{FF2B5EF4-FFF2-40B4-BE49-F238E27FC236}">
                <a16:creationId xmlns:a16="http://schemas.microsoft.com/office/drawing/2014/main" id="{E7F33FC8-58AB-55B4-3280-3B616C6CC0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4346802"/>
              </p:ext>
            </p:extLst>
          </p:nvPr>
        </p:nvGraphicFramePr>
        <p:xfrm>
          <a:off x="3090056" y="2474303"/>
          <a:ext cx="3014134" cy="4328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표 5">
            <a:extLst>
              <a:ext uri="{FF2B5EF4-FFF2-40B4-BE49-F238E27FC236}">
                <a16:creationId xmlns:a16="http://schemas.microsoft.com/office/drawing/2014/main" id="{D3BA8B1D-585F-9D1E-029F-AFC7C1F4BD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3225123"/>
              </p:ext>
            </p:extLst>
          </p:nvPr>
        </p:nvGraphicFramePr>
        <p:xfrm>
          <a:off x="795589" y="2621359"/>
          <a:ext cx="2531533" cy="3879910"/>
        </p:xfrm>
        <a:graphic>
          <a:graphicData uri="http://schemas.openxmlformats.org/drawingml/2006/table">
            <a:tbl>
              <a:tblPr/>
              <a:tblGrid>
                <a:gridCol w="541865">
                  <a:extLst>
                    <a:ext uri="{9D8B030D-6E8A-4147-A177-3AD203B41FA5}">
                      <a16:colId xmlns:a16="http://schemas.microsoft.com/office/drawing/2014/main" val="1279644516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3408418391"/>
                    </a:ext>
                  </a:extLst>
                </a:gridCol>
                <a:gridCol w="732368">
                  <a:extLst>
                    <a:ext uri="{9D8B030D-6E8A-4147-A177-3AD203B41FA5}">
                      <a16:colId xmlns:a16="http://schemas.microsoft.com/office/drawing/2014/main" val="58854284"/>
                    </a:ext>
                  </a:extLst>
                </a:gridCol>
              </a:tblGrid>
              <a:tr h="228230"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lade 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4G2032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C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5641752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6G1623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C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5755252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5G1987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E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62265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8G0059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E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4154114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3G2363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B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358477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19G2339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B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271272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10G1522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I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0309025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20G2362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I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434572"/>
                  </a:ext>
                </a:extLst>
              </a:tr>
              <a:tr h="228230"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lade 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1G2227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A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968475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11G0207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A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7822897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5G2125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F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36881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8G0189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F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898337"/>
                  </a:ext>
                </a:extLst>
              </a:tr>
              <a:tr h="2282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lade 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7G1308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G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362310"/>
                  </a:ext>
                </a:extLst>
              </a:tr>
              <a:tr h="22823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lade 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9G0732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H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412889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15G1820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H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179438"/>
                  </a:ext>
                </a:extLst>
              </a:tr>
              <a:tr h="22823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lade 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05G0211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D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8545798"/>
                  </a:ext>
                </a:extLst>
              </a:tr>
              <a:tr h="228230"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lyma.17G07830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mRbohD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1525172"/>
                  </a:ext>
                </a:extLst>
              </a:tr>
            </a:tbl>
          </a:graphicData>
        </a:graphic>
      </p:graphicFrame>
      <p:cxnSp>
        <p:nvCxnSpPr>
          <p:cNvPr id="13" name="직선 연결선 7">
            <a:extLst>
              <a:ext uri="{FF2B5EF4-FFF2-40B4-BE49-F238E27FC236}">
                <a16:creationId xmlns:a16="http://schemas.microsoft.com/office/drawing/2014/main" id="{D76E2B02-7094-5EB0-BE98-2D73B81BA2AA}"/>
              </a:ext>
            </a:extLst>
          </p:cNvPr>
          <p:cNvCxnSpPr/>
          <p:nvPr/>
        </p:nvCxnSpPr>
        <p:spPr>
          <a:xfrm>
            <a:off x="1227389" y="2699728"/>
            <a:ext cx="0" cy="169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8">
            <a:extLst>
              <a:ext uri="{FF2B5EF4-FFF2-40B4-BE49-F238E27FC236}">
                <a16:creationId xmlns:a16="http://schemas.microsoft.com/office/drawing/2014/main" id="{A3CAC158-68FB-24A6-CA96-18907EE89937}"/>
              </a:ext>
            </a:extLst>
          </p:cNvPr>
          <p:cNvCxnSpPr/>
          <p:nvPr/>
        </p:nvCxnSpPr>
        <p:spPr>
          <a:xfrm>
            <a:off x="1227387" y="4511597"/>
            <a:ext cx="0" cy="79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9">
            <a:extLst>
              <a:ext uri="{FF2B5EF4-FFF2-40B4-BE49-F238E27FC236}">
                <a16:creationId xmlns:a16="http://schemas.microsoft.com/office/drawing/2014/main" id="{A650CED7-867C-92FC-5847-2BCC8B7E293C}"/>
              </a:ext>
            </a:extLst>
          </p:cNvPr>
          <p:cNvCxnSpPr/>
          <p:nvPr/>
        </p:nvCxnSpPr>
        <p:spPr>
          <a:xfrm>
            <a:off x="1227387" y="5400598"/>
            <a:ext cx="0" cy="14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0">
            <a:extLst>
              <a:ext uri="{FF2B5EF4-FFF2-40B4-BE49-F238E27FC236}">
                <a16:creationId xmlns:a16="http://schemas.microsoft.com/office/drawing/2014/main" id="{992C213A-F9B1-9811-4680-2ED894763DF7}"/>
              </a:ext>
            </a:extLst>
          </p:cNvPr>
          <p:cNvCxnSpPr/>
          <p:nvPr/>
        </p:nvCxnSpPr>
        <p:spPr>
          <a:xfrm>
            <a:off x="1235852" y="5663066"/>
            <a:ext cx="0" cy="32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1">
            <a:extLst>
              <a:ext uri="{FF2B5EF4-FFF2-40B4-BE49-F238E27FC236}">
                <a16:creationId xmlns:a16="http://schemas.microsoft.com/office/drawing/2014/main" id="{685E7DF1-3F04-ED54-A292-CADD376A3D53}"/>
              </a:ext>
            </a:extLst>
          </p:cNvPr>
          <p:cNvCxnSpPr/>
          <p:nvPr/>
        </p:nvCxnSpPr>
        <p:spPr>
          <a:xfrm>
            <a:off x="1235852" y="6120266"/>
            <a:ext cx="0" cy="32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직사각형 15">
            <a:extLst>
              <a:ext uri="{FF2B5EF4-FFF2-40B4-BE49-F238E27FC236}">
                <a16:creationId xmlns:a16="http://schemas.microsoft.com/office/drawing/2014/main" id="{E663A0D9-1615-DCEA-5715-A87CBDD9192C}"/>
              </a:ext>
            </a:extLst>
          </p:cNvPr>
          <p:cNvSpPr/>
          <p:nvPr/>
        </p:nvSpPr>
        <p:spPr>
          <a:xfrm>
            <a:off x="3809087" y="6709750"/>
            <a:ext cx="15760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solidFill>
                  <a:srgbClr val="000000"/>
                </a:solidFill>
              </a:rPr>
              <a:t>Ratio of TPM (Salt/control)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872568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그룹 29"/>
          <p:cNvGrpSpPr/>
          <p:nvPr/>
        </p:nvGrpSpPr>
        <p:grpSpPr>
          <a:xfrm>
            <a:off x="1684771" y="1968142"/>
            <a:ext cx="3511375" cy="5036410"/>
            <a:chOff x="1829150" y="1907984"/>
            <a:chExt cx="3511375" cy="5036410"/>
          </a:xfrm>
        </p:grpSpPr>
        <p:graphicFrame>
          <p:nvGraphicFramePr>
            <p:cNvPr id="5" name="Chart 12">
              <a:extLst>
                <a:ext uri="{FF2B5EF4-FFF2-40B4-BE49-F238E27FC236}">
                  <a16:creationId xmlns:a16="http://schemas.microsoft.com/office/drawing/2014/main" id="{F5414EEC-35BB-69F8-3443-64C5B801C80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44141166"/>
                </p:ext>
              </p:extLst>
            </p:nvPr>
          </p:nvGraphicFramePr>
          <p:xfrm>
            <a:off x="2358283" y="2101736"/>
            <a:ext cx="2850044" cy="17896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8217915-AC5C-D011-B2AB-7C98681D9982}"/>
                </a:ext>
              </a:extLst>
            </p:cNvPr>
            <p:cNvSpPr txBox="1"/>
            <p:nvPr/>
          </p:nvSpPr>
          <p:spPr>
            <a:xfrm rot="16200000">
              <a:off x="1504012" y="2478764"/>
              <a:ext cx="15416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elative expression</a:t>
              </a:r>
            </a:p>
            <a:p>
              <a:pPr algn="ctr"/>
              <a:r>
                <a:rPr lang="en-US" sz="1000" dirty="0"/>
                <a:t> (</a:t>
              </a:r>
              <a:r>
                <a:rPr lang="en-US" sz="1000" i="1" dirty="0"/>
                <a:t>GmRbohI1/</a:t>
              </a:r>
              <a:r>
                <a:rPr lang="en-US" sz="1000" i="1" dirty="0" err="1"/>
                <a:t>GmActin</a:t>
              </a:r>
              <a:r>
                <a:rPr lang="en-US" sz="1000" i="1" dirty="0"/>
                <a:t>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FBDCD79-704D-EBE4-6866-4E7982800C68}"/>
                </a:ext>
              </a:extLst>
            </p:cNvPr>
            <p:cNvSpPr txBox="1"/>
            <p:nvPr/>
          </p:nvSpPr>
          <p:spPr>
            <a:xfrm>
              <a:off x="2650328" y="6657540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245CA33-4EC2-5314-F943-053CCBB5D0D7}"/>
                </a:ext>
              </a:extLst>
            </p:cNvPr>
            <p:cNvSpPr txBox="1"/>
            <p:nvPr/>
          </p:nvSpPr>
          <p:spPr>
            <a:xfrm>
              <a:off x="2987581" y="6657539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C76C80D-34D0-DCFC-4CCA-83C2F0A5DAED}"/>
                </a:ext>
              </a:extLst>
            </p:cNvPr>
            <p:cNvSpPr txBox="1"/>
            <p:nvPr/>
          </p:nvSpPr>
          <p:spPr>
            <a:xfrm>
              <a:off x="3325966" y="6657540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A50834B-C88B-1CE0-8073-D85180ECBBE7}"/>
                </a:ext>
              </a:extLst>
            </p:cNvPr>
            <p:cNvSpPr txBox="1"/>
            <p:nvPr/>
          </p:nvSpPr>
          <p:spPr>
            <a:xfrm>
              <a:off x="3666075" y="6657539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E7B03A8-6626-4FAB-334B-E81A283B0874}"/>
                </a:ext>
              </a:extLst>
            </p:cNvPr>
            <p:cNvSpPr txBox="1"/>
            <p:nvPr/>
          </p:nvSpPr>
          <p:spPr>
            <a:xfrm>
              <a:off x="4007637" y="6657538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8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D9BA96F-C7FD-FBD2-1127-153EADA9302E}"/>
                </a:ext>
              </a:extLst>
            </p:cNvPr>
            <p:cNvSpPr txBox="1"/>
            <p:nvPr/>
          </p:nvSpPr>
          <p:spPr>
            <a:xfrm>
              <a:off x="4347850" y="6657538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1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2588A22-12E0-46F5-6D5D-14B13145BC2B}"/>
                </a:ext>
              </a:extLst>
            </p:cNvPr>
            <p:cNvSpPr txBox="1"/>
            <p:nvPr/>
          </p:nvSpPr>
          <p:spPr>
            <a:xfrm>
              <a:off x="4689624" y="6648011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24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338712D-5F25-7204-A270-10FF039B8DC9}"/>
                </a:ext>
              </a:extLst>
            </p:cNvPr>
            <p:cNvSpPr txBox="1"/>
            <p:nvPr/>
          </p:nvSpPr>
          <p:spPr>
            <a:xfrm>
              <a:off x="4936665" y="6657537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(h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30ED0DC-B0F7-7F82-4E92-AD89B6396592}"/>
                </a:ext>
              </a:extLst>
            </p:cNvPr>
            <p:cNvSpPr txBox="1"/>
            <p:nvPr/>
          </p:nvSpPr>
          <p:spPr>
            <a:xfrm>
              <a:off x="1829150" y="6663248"/>
              <a:ext cx="9376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0.3 M NaCl</a:t>
              </a:r>
            </a:p>
          </p:txBody>
        </p:sp>
        <p:graphicFrame>
          <p:nvGraphicFramePr>
            <p:cNvPr id="26" name="차트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30814846"/>
                </p:ext>
              </p:extLst>
            </p:nvPr>
          </p:nvGraphicFramePr>
          <p:xfrm>
            <a:off x="2389565" y="3555286"/>
            <a:ext cx="2818762" cy="16589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7" name="차트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0715873"/>
                </p:ext>
              </p:extLst>
            </p:nvPr>
          </p:nvGraphicFramePr>
          <p:xfrm>
            <a:off x="2389565" y="5155281"/>
            <a:ext cx="2818762" cy="17891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8217915-AC5C-D011-B2AB-7C98681D9982}"/>
                </a:ext>
              </a:extLst>
            </p:cNvPr>
            <p:cNvSpPr txBox="1"/>
            <p:nvPr/>
          </p:nvSpPr>
          <p:spPr>
            <a:xfrm rot="16200000">
              <a:off x="1504010" y="4131575"/>
              <a:ext cx="15416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elative expression</a:t>
              </a:r>
            </a:p>
            <a:p>
              <a:pPr algn="ctr"/>
              <a:r>
                <a:rPr lang="en-US" sz="1000" dirty="0"/>
                <a:t> (</a:t>
              </a:r>
              <a:r>
                <a:rPr lang="en-US" sz="1000" i="1" dirty="0"/>
                <a:t>GmRbohI1/</a:t>
              </a:r>
              <a:r>
                <a:rPr lang="en-US" sz="1000" i="1" dirty="0" err="1"/>
                <a:t>GmTubulin</a:t>
              </a:r>
              <a:r>
                <a:rPr lang="en-US" sz="1000" i="1" dirty="0"/>
                <a:t>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8217915-AC5C-D011-B2AB-7C98681D9982}"/>
                </a:ext>
              </a:extLst>
            </p:cNvPr>
            <p:cNvSpPr txBox="1"/>
            <p:nvPr/>
          </p:nvSpPr>
          <p:spPr>
            <a:xfrm rot="16200000">
              <a:off x="1504010" y="5751319"/>
              <a:ext cx="15416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elative expression</a:t>
              </a:r>
            </a:p>
            <a:p>
              <a:pPr algn="ctr"/>
              <a:r>
                <a:rPr lang="en-US" sz="1000" dirty="0"/>
                <a:t> (</a:t>
              </a:r>
              <a:r>
                <a:rPr lang="en-US" sz="1000" i="1" dirty="0"/>
                <a:t>GmRbohI1/</a:t>
              </a:r>
              <a:r>
                <a:rPr lang="en-US" sz="1000" i="1" dirty="0" err="1"/>
                <a:t>GmUBQ</a:t>
              </a:r>
              <a:r>
                <a:rPr lang="en-US" sz="1000" i="1" dirty="0"/>
                <a:t>)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B3BB2377-DBB6-11C0-043B-F58284D61801}"/>
              </a:ext>
            </a:extLst>
          </p:cNvPr>
          <p:cNvSpPr txBox="1"/>
          <p:nvPr/>
        </p:nvSpPr>
        <p:spPr>
          <a:xfrm>
            <a:off x="133159" y="7734338"/>
            <a:ext cx="62278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2. Gene expression of </a:t>
            </a:r>
            <a:r>
              <a:rPr lang="en-US" sz="1200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bohI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ith three different reference genes. Seven-day-old soybean seedlings were treated with 0.3 M NaCl at designated time points. For RT-qPCR analysis, total RNA was isolated, and the amplification was carried out with gene specific primers (Table S1). Data are means ± SD of three repeats.</a:t>
            </a:r>
          </a:p>
          <a:p>
            <a:endParaRPr lang="en-US" sz="12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9580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1B4F82-A5AB-196C-331B-51ACBEE3E3C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53800" t="15393" r="26151" b="49802"/>
          <a:stretch/>
        </p:blipFill>
        <p:spPr bwMode="auto">
          <a:xfrm>
            <a:off x="2971801" y="2677359"/>
            <a:ext cx="1095375" cy="19095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B25DD12-99AD-0479-0232-E569DC6F3F18}"/>
              </a:ext>
            </a:extLst>
          </p:cNvPr>
          <p:cNvSpPr txBox="1"/>
          <p:nvPr/>
        </p:nvSpPr>
        <p:spPr>
          <a:xfrm>
            <a:off x="2028826" y="2061805"/>
            <a:ext cx="933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GMKK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7BA993-84DD-FC1D-289F-0B7429D2E5FA}"/>
              </a:ext>
            </a:extLst>
          </p:cNvPr>
          <p:cNvSpPr txBox="1"/>
          <p:nvPr/>
        </p:nvSpPr>
        <p:spPr>
          <a:xfrm>
            <a:off x="2028826" y="2369582"/>
            <a:ext cx="933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GmMPK</a:t>
            </a:r>
            <a:endParaRPr lang="en-US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05397F-9EA0-BE0A-0972-AD100AD5A8C9}"/>
              </a:ext>
            </a:extLst>
          </p:cNvPr>
          <p:cNvSpPr txBox="1"/>
          <p:nvPr/>
        </p:nvSpPr>
        <p:spPr>
          <a:xfrm>
            <a:off x="2971801" y="2061805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F5EA35-6750-54DC-E69A-68D328FF1A1C}"/>
              </a:ext>
            </a:extLst>
          </p:cNvPr>
          <p:cNvSpPr txBox="1"/>
          <p:nvPr/>
        </p:nvSpPr>
        <p:spPr>
          <a:xfrm>
            <a:off x="3224213" y="2061804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0DA5CDB-A245-199D-7929-054775CA8112}"/>
              </a:ext>
            </a:extLst>
          </p:cNvPr>
          <p:cNvSpPr txBox="1"/>
          <p:nvPr/>
        </p:nvSpPr>
        <p:spPr>
          <a:xfrm>
            <a:off x="3486153" y="2063814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D8ABFBB-0F54-F35F-B699-4CB3BF4547EF}"/>
              </a:ext>
            </a:extLst>
          </p:cNvPr>
          <p:cNvSpPr txBox="1"/>
          <p:nvPr/>
        </p:nvSpPr>
        <p:spPr>
          <a:xfrm>
            <a:off x="3738565" y="2063814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24A7155-99E0-C505-DE2D-4E3B36A10410}"/>
              </a:ext>
            </a:extLst>
          </p:cNvPr>
          <p:cNvSpPr txBox="1"/>
          <p:nvPr/>
        </p:nvSpPr>
        <p:spPr>
          <a:xfrm>
            <a:off x="2971801" y="2365563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79E884-45BA-6AEF-4181-609A153EE4C0}"/>
              </a:ext>
            </a:extLst>
          </p:cNvPr>
          <p:cNvSpPr txBox="1"/>
          <p:nvPr/>
        </p:nvSpPr>
        <p:spPr>
          <a:xfrm>
            <a:off x="3224213" y="2365562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3FBC4B3-D89A-D644-2ABF-22E721C9F26A}"/>
              </a:ext>
            </a:extLst>
          </p:cNvPr>
          <p:cNvSpPr txBox="1"/>
          <p:nvPr/>
        </p:nvSpPr>
        <p:spPr>
          <a:xfrm>
            <a:off x="3486153" y="2367572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91D59D-935B-B7CE-0C60-B692F2579644}"/>
              </a:ext>
            </a:extLst>
          </p:cNvPr>
          <p:cNvSpPr txBox="1"/>
          <p:nvPr/>
        </p:nvSpPr>
        <p:spPr>
          <a:xfrm>
            <a:off x="3738565" y="2367572"/>
            <a:ext cx="40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1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BB2377-DBB6-11C0-043B-F58284D61801}"/>
              </a:ext>
            </a:extLst>
          </p:cNvPr>
          <p:cNvSpPr txBox="1"/>
          <p:nvPr/>
        </p:nvSpPr>
        <p:spPr>
          <a:xfrm>
            <a:off x="315097" y="5050655"/>
            <a:ext cx="62278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.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vitro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nase assay of GMKK1 with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MPK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E-coli expressed and purified GMKK1 was mixed with GmMPK3, 6 and 10, respectively and carried out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vitro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kinase assay with myelin basic protein (MBP) as MPK substrate. After the reaction, the proteins were separated with SDS-PAGE and analyzed  autoradiography with phosphor imager.</a:t>
            </a:r>
            <a:endParaRPr lang="ko-KR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C3881C-9BCD-6DD9-1000-72D9F1F337DC}"/>
              </a:ext>
            </a:extLst>
          </p:cNvPr>
          <p:cNvSpPr txBox="1"/>
          <p:nvPr/>
        </p:nvSpPr>
        <p:spPr>
          <a:xfrm>
            <a:off x="2038351" y="3910664"/>
            <a:ext cx="933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BP</a:t>
            </a:r>
          </a:p>
        </p:txBody>
      </p:sp>
    </p:spTree>
    <p:extLst>
      <p:ext uri="{BB962C8B-B14F-4D97-AF65-F5344CB8AC3E}">
        <p14:creationId xmlns:p14="http://schemas.microsoft.com/office/powerpoint/2010/main" val="4224248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0AF7428A-7189-432D-AC60-ADC5B877ABF6}"/>
              </a:ext>
            </a:extLst>
          </p:cNvPr>
          <p:cNvGrpSpPr/>
          <p:nvPr/>
        </p:nvGrpSpPr>
        <p:grpSpPr>
          <a:xfrm>
            <a:off x="1546101" y="3009977"/>
            <a:ext cx="3425502" cy="1943023"/>
            <a:chOff x="1437459" y="2460759"/>
            <a:chExt cx="3425502" cy="1943023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35CC7B8-EAE0-B2F9-BDE9-5ABF6CE6CC57}"/>
                </a:ext>
              </a:extLst>
            </p:cNvPr>
            <p:cNvSpPr txBox="1"/>
            <p:nvPr/>
          </p:nvSpPr>
          <p:spPr>
            <a:xfrm rot="16200000">
              <a:off x="1186794" y="3053197"/>
              <a:ext cx="14097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bsorbance at 470 nm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0C0B6D1-4E91-7830-34DD-BFA068C635C7}"/>
                </a:ext>
              </a:extLst>
            </p:cNvPr>
            <p:cNvSpPr txBox="1"/>
            <p:nvPr/>
          </p:nvSpPr>
          <p:spPr>
            <a:xfrm>
              <a:off x="2254251" y="3814217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B145795-F634-54D9-4AD7-2B3075A36CB5}"/>
                </a:ext>
              </a:extLst>
            </p:cNvPr>
            <p:cNvSpPr txBox="1"/>
            <p:nvPr/>
          </p:nvSpPr>
          <p:spPr>
            <a:xfrm>
              <a:off x="2642304" y="3815010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2D88949-1DA5-0A66-DEA3-17F7158A1F5F}"/>
                </a:ext>
              </a:extLst>
            </p:cNvPr>
            <p:cNvSpPr txBox="1"/>
            <p:nvPr/>
          </p:nvSpPr>
          <p:spPr>
            <a:xfrm>
              <a:off x="3025140" y="3815011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4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CA99CC8-8D78-F8C0-6FC4-0AE36C66ADC5}"/>
                </a:ext>
              </a:extLst>
            </p:cNvPr>
            <p:cNvSpPr txBox="1"/>
            <p:nvPr/>
          </p:nvSpPr>
          <p:spPr>
            <a:xfrm>
              <a:off x="3389856" y="3815010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8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23CF507-38BB-12A2-6585-F43EE9751E56}"/>
                </a:ext>
              </a:extLst>
            </p:cNvPr>
            <p:cNvSpPr txBox="1"/>
            <p:nvPr/>
          </p:nvSpPr>
          <p:spPr>
            <a:xfrm>
              <a:off x="3767931" y="3815009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1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2BD286E-90E2-41A0-51C5-C1CD329165BC}"/>
                </a:ext>
              </a:extLst>
            </p:cNvPr>
            <p:cNvSpPr txBox="1"/>
            <p:nvPr/>
          </p:nvSpPr>
          <p:spPr>
            <a:xfrm>
              <a:off x="4125608" y="3811834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2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AAD8BA8-EA35-364C-FD97-DA959365A2BA}"/>
                </a:ext>
              </a:extLst>
            </p:cNvPr>
            <p:cNvSpPr txBox="1"/>
            <p:nvPr/>
          </p:nvSpPr>
          <p:spPr>
            <a:xfrm>
              <a:off x="1437459" y="3818969"/>
              <a:ext cx="9376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0.3 M NaC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D7E3297-A707-D980-7463-11572726984D}"/>
                </a:ext>
              </a:extLst>
            </p:cNvPr>
            <p:cNvSpPr txBox="1"/>
            <p:nvPr/>
          </p:nvSpPr>
          <p:spPr>
            <a:xfrm>
              <a:off x="3404090" y="3295900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**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D9533A9-9634-8CF1-5ACD-95E4FF26CE5F}"/>
                </a:ext>
              </a:extLst>
            </p:cNvPr>
            <p:cNvSpPr txBox="1"/>
            <p:nvPr/>
          </p:nvSpPr>
          <p:spPr>
            <a:xfrm>
              <a:off x="3394573" y="3476981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**</a:t>
              </a:r>
            </a:p>
          </p:txBody>
        </p:sp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B61AAD6D-D255-B183-5484-176CFBBEF3C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98776333"/>
                </p:ext>
              </p:extLst>
            </p:nvPr>
          </p:nvGraphicFramePr>
          <p:xfrm>
            <a:off x="1931940" y="2460759"/>
            <a:ext cx="2735003" cy="19430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F6E7942-2B7E-435B-22A1-D3351A8CCB84}"/>
                </a:ext>
              </a:extLst>
            </p:cNvPr>
            <p:cNvSpPr txBox="1"/>
            <p:nvPr/>
          </p:nvSpPr>
          <p:spPr>
            <a:xfrm>
              <a:off x="4459101" y="3821517"/>
              <a:ext cx="403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(h)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F5A39E71-A13A-8F24-DA6F-CF6091967778}"/>
              </a:ext>
            </a:extLst>
          </p:cNvPr>
          <p:cNvSpPr txBox="1"/>
          <p:nvPr/>
        </p:nvSpPr>
        <p:spPr>
          <a:xfrm>
            <a:off x="380246" y="4987912"/>
            <a:ext cx="612919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4. ROS generation in </a:t>
            </a:r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oybean seedings by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3 M NaCl treatment with or without pretreatment of SB202190 or DPI. Seven-day-old soybean seedings were treated with or without 30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B202190 or 50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PI for 1 h and followed by treated with 0.3 M NaCl and 0.5 mM XTT for designated time points. The ROS generation was measured with spectrophotometer at 470 nm. Data are means ± SD of three repeats: **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46086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B442614F-EE12-2A3A-0B43-0C50755A2485}"/>
              </a:ext>
            </a:extLst>
          </p:cNvPr>
          <p:cNvSpPr txBox="1"/>
          <p:nvPr/>
        </p:nvSpPr>
        <p:spPr>
          <a:xfrm>
            <a:off x="380246" y="4953000"/>
            <a:ext cx="61201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5. Phenotype of 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oybean leaves co-treated with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0 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NaCl and various inhibitors. Ten-day-old soybean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edlings were respectively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reated with in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0 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NaCl, 30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μ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B202190 +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0 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NaCl, and 50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μ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DPI +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0 m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NaCl. 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&amp;D solution treated soybean seedlings were used as a control. I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ages were taken after 5 days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f treatmen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picture containing text, indoor&#10;&#10;Description automatically generated">
            <a:extLst>
              <a:ext uri="{FF2B5EF4-FFF2-40B4-BE49-F238E27FC236}">
                <a16:creationId xmlns:a16="http://schemas.microsoft.com/office/drawing/2014/main" id="{A28A8317-3542-30A1-BB56-9D321EDA61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4238" y="2187166"/>
            <a:ext cx="2409524" cy="251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4957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4">
            <a:extLst>
              <a:ext uri="{FF2B5EF4-FFF2-40B4-BE49-F238E27FC236}">
                <a16:creationId xmlns:a16="http://schemas.microsoft.com/office/drawing/2014/main" id="{F94EB29E-0FC7-4E50-887B-990BB0AC26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4223614"/>
              </p:ext>
            </p:extLst>
          </p:nvPr>
        </p:nvGraphicFramePr>
        <p:xfrm>
          <a:off x="2046489" y="4450257"/>
          <a:ext cx="2709040" cy="1628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846892C-79BE-4D13-A1A0-3F8D1E912476}"/>
              </a:ext>
            </a:extLst>
          </p:cNvPr>
          <p:cNvSpPr txBox="1"/>
          <p:nvPr/>
        </p:nvSpPr>
        <p:spPr>
          <a:xfrm>
            <a:off x="3034849" y="5987901"/>
            <a:ext cx="926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.3 M H</a:t>
            </a:r>
            <a:r>
              <a:rPr lang="en-US" sz="1000" baseline="-25000" dirty="0"/>
              <a:t>2</a:t>
            </a:r>
            <a:r>
              <a:rPr lang="en-US" sz="1000" dirty="0"/>
              <a:t>O</a:t>
            </a:r>
            <a:r>
              <a:rPr lang="en-US" sz="1000" baseline="-25000" dirty="0"/>
              <a:t>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407F7B-C484-47AF-B7CD-9ECE1B1C2DFD}"/>
              </a:ext>
            </a:extLst>
          </p:cNvPr>
          <p:cNvSpPr txBox="1"/>
          <p:nvPr/>
        </p:nvSpPr>
        <p:spPr>
          <a:xfrm>
            <a:off x="2434822" y="5792646"/>
            <a:ext cx="4370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4EA025-E319-4BC7-8BB1-2BC963342967}"/>
              </a:ext>
            </a:extLst>
          </p:cNvPr>
          <p:cNvSpPr txBox="1"/>
          <p:nvPr/>
        </p:nvSpPr>
        <p:spPr>
          <a:xfrm>
            <a:off x="2988436" y="5792645"/>
            <a:ext cx="4370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F55977-DFB4-405A-9062-7013842E3146}"/>
              </a:ext>
            </a:extLst>
          </p:cNvPr>
          <p:cNvSpPr txBox="1"/>
          <p:nvPr/>
        </p:nvSpPr>
        <p:spPr>
          <a:xfrm>
            <a:off x="3545894" y="5792644"/>
            <a:ext cx="4370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FBD772-DB2A-45E1-BE1C-3578503F5B6B}"/>
              </a:ext>
            </a:extLst>
          </p:cNvPr>
          <p:cNvSpPr txBox="1"/>
          <p:nvPr/>
        </p:nvSpPr>
        <p:spPr>
          <a:xfrm>
            <a:off x="4109832" y="5792643"/>
            <a:ext cx="4370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A9EC28-1416-4FFD-998C-295E1EC2E630}"/>
              </a:ext>
            </a:extLst>
          </p:cNvPr>
          <p:cNvSpPr txBox="1"/>
          <p:nvPr/>
        </p:nvSpPr>
        <p:spPr>
          <a:xfrm>
            <a:off x="4484217" y="5792642"/>
            <a:ext cx="4370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(h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6CDA19-FEB9-4CD4-9369-E8D6AA258A59}"/>
              </a:ext>
            </a:extLst>
          </p:cNvPr>
          <p:cNvSpPr txBox="1"/>
          <p:nvPr/>
        </p:nvSpPr>
        <p:spPr>
          <a:xfrm rot="16200000">
            <a:off x="1385292" y="5068927"/>
            <a:ext cx="12542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elative expression</a:t>
            </a:r>
            <a:endParaRPr lang="en-US" sz="1000" i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B275ED4-65A1-4C93-A348-9A44EAE53D1B}"/>
              </a:ext>
            </a:extLst>
          </p:cNvPr>
          <p:cNvSpPr txBox="1"/>
          <p:nvPr/>
        </p:nvSpPr>
        <p:spPr>
          <a:xfrm>
            <a:off x="214953" y="6389923"/>
            <a:ext cx="62278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6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Expression of </a:t>
            </a:r>
            <a:r>
              <a:rPr lang="en-US" sz="1200" i="1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mRD19A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NaCl or H</a:t>
            </a:r>
            <a:r>
              <a:rPr lang="en-US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</a:t>
            </a:r>
            <a:r>
              <a:rPr lang="en-US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ed soybean seedlings. Seven-day-old soybean seedlings were treated with 0.3 M 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Cl (A) or 0.3 M H</a:t>
            </a:r>
            <a:r>
              <a:rPr lang="en-US" altLang="ko-KR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</a:t>
            </a:r>
            <a:r>
              <a:rPr lang="en-US" altLang="ko-KR" sz="1200" kern="100" baseline="-25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B) for designated time points. For RT-qPCR analysis, total RNA was isolated, and the amplification was carried out with gene specific primers (Table S1). </a:t>
            </a:r>
            <a:r>
              <a:rPr lang="en-US" altLang="ko-KR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ata are means ± SD of three repeat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D226EE-6A7C-4F6C-8A82-E560505AF80D}"/>
              </a:ext>
            </a:extLst>
          </p:cNvPr>
          <p:cNvSpPr txBox="1"/>
          <p:nvPr/>
        </p:nvSpPr>
        <p:spPr>
          <a:xfrm>
            <a:off x="2417604" y="3726387"/>
            <a:ext cx="403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D5C0A3C-E493-411A-8FD5-A29532A812B6}"/>
              </a:ext>
            </a:extLst>
          </p:cNvPr>
          <p:cNvSpPr txBox="1"/>
          <p:nvPr/>
        </p:nvSpPr>
        <p:spPr>
          <a:xfrm>
            <a:off x="3002505" y="3727179"/>
            <a:ext cx="403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673D4FE-3C97-40FC-9456-03AEBA10A861}"/>
              </a:ext>
            </a:extLst>
          </p:cNvPr>
          <p:cNvSpPr txBox="1"/>
          <p:nvPr/>
        </p:nvSpPr>
        <p:spPr>
          <a:xfrm>
            <a:off x="3579014" y="3727180"/>
            <a:ext cx="403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908238-361B-47A7-BE4F-531050F7A159}"/>
              </a:ext>
            </a:extLst>
          </p:cNvPr>
          <p:cNvSpPr txBox="1"/>
          <p:nvPr/>
        </p:nvSpPr>
        <p:spPr>
          <a:xfrm>
            <a:off x="4153277" y="3727179"/>
            <a:ext cx="403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6E0D44-E0EB-4B77-914F-238DC7F762FA}"/>
              </a:ext>
            </a:extLst>
          </p:cNvPr>
          <p:cNvSpPr txBox="1"/>
          <p:nvPr/>
        </p:nvSpPr>
        <p:spPr>
          <a:xfrm>
            <a:off x="4501165" y="3727178"/>
            <a:ext cx="403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(h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213B9A-53D3-47CB-BF95-8F4F102FB23D}"/>
              </a:ext>
            </a:extLst>
          </p:cNvPr>
          <p:cNvSpPr txBox="1"/>
          <p:nvPr/>
        </p:nvSpPr>
        <p:spPr>
          <a:xfrm>
            <a:off x="3019041" y="3918372"/>
            <a:ext cx="9376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0.3 M NaC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453578-A8DF-4ECD-A14A-9FC49550DB58}"/>
              </a:ext>
            </a:extLst>
          </p:cNvPr>
          <p:cNvSpPr txBox="1"/>
          <p:nvPr/>
        </p:nvSpPr>
        <p:spPr>
          <a:xfrm rot="16200000">
            <a:off x="1383778" y="3019209"/>
            <a:ext cx="12148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elative expression</a:t>
            </a:r>
            <a:endParaRPr lang="en-US" sz="1000" i="1" dirty="0"/>
          </a:p>
        </p:txBody>
      </p:sp>
      <p:graphicFrame>
        <p:nvGraphicFramePr>
          <p:cNvPr id="29" name="Chart 145">
            <a:extLst>
              <a:ext uri="{FF2B5EF4-FFF2-40B4-BE49-F238E27FC236}">
                <a16:creationId xmlns:a16="http://schemas.microsoft.com/office/drawing/2014/main" id="{5DC9105C-019D-460C-815F-830274277E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2116188"/>
              </p:ext>
            </p:extLst>
          </p:nvPr>
        </p:nvGraphicFramePr>
        <p:xfrm>
          <a:off x="2070999" y="2410073"/>
          <a:ext cx="2709040" cy="1628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2AF12E9-150E-B8E9-5BF4-EA3934F7B47D}"/>
              </a:ext>
            </a:extLst>
          </p:cNvPr>
          <p:cNvSpPr txBox="1"/>
          <p:nvPr/>
        </p:nvSpPr>
        <p:spPr>
          <a:xfrm>
            <a:off x="1456110" y="2164057"/>
            <a:ext cx="489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6325080-B4C4-650B-3D63-09BC7FD6D6CC}"/>
              </a:ext>
            </a:extLst>
          </p:cNvPr>
          <p:cNvSpPr txBox="1"/>
          <p:nvPr/>
        </p:nvSpPr>
        <p:spPr>
          <a:xfrm>
            <a:off x="1472385" y="4255256"/>
            <a:ext cx="489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309021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EE328F6-6570-271F-9541-C39337EB49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3221497"/>
              </p:ext>
            </p:extLst>
          </p:nvPr>
        </p:nvGraphicFramePr>
        <p:xfrm>
          <a:off x="438149" y="3389969"/>
          <a:ext cx="5981702" cy="3530408"/>
        </p:xfrm>
        <a:graphic>
          <a:graphicData uri="http://schemas.openxmlformats.org/drawingml/2006/table">
            <a:tbl>
              <a:tblPr/>
              <a:tblGrid>
                <a:gridCol w="1665433">
                  <a:extLst>
                    <a:ext uri="{9D8B030D-6E8A-4147-A177-3AD203B41FA5}">
                      <a16:colId xmlns:a16="http://schemas.microsoft.com/office/drawing/2014/main" val="2721906900"/>
                    </a:ext>
                  </a:extLst>
                </a:gridCol>
                <a:gridCol w="1665433">
                  <a:extLst>
                    <a:ext uri="{9D8B030D-6E8A-4147-A177-3AD203B41FA5}">
                      <a16:colId xmlns:a16="http://schemas.microsoft.com/office/drawing/2014/main" val="984978431"/>
                    </a:ext>
                  </a:extLst>
                </a:gridCol>
                <a:gridCol w="2650836">
                  <a:extLst>
                    <a:ext uri="{9D8B030D-6E8A-4147-A177-3AD203B41FA5}">
                      <a16:colId xmlns:a16="http://schemas.microsoft.com/office/drawing/2014/main" val="494139910"/>
                    </a:ext>
                  </a:extLst>
                </a:gridCol>
              </a:tblGrid>
              <a:tr h="229373">
                <a:tc>
                  <a:txBody>
                    <a:bodyPr/>
                    <a:lstStyle/>
                    <a:p>
                      <a:pPr marL="0" marR="0" algn="l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Purpose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Name                               Sequence (5' to 3')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33090287"/>
                  </a:ext>
                </a:extLst>
              </a:tr>
              <a:tr h="228530">
                <a:tc rowSpan="16">
                  <a:txBody>
                    <a:bodyPr/>
                    <a:lstStyle/>
                    <a:p>
                      <a:pPr marL="0" marR="0" algn="l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RT-q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RbohB1-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AAAGTGGAGTCAAGAACAAGAG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0231915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RbohIB1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GTTCTATTATTCCATCCTTGTCATAC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1434502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pPr marL="0" marR="0" algn="ctr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B2-F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ACAACAAGAAGAGCAGCAAG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817127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B2-R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AGCACCAGACTTGGTCCT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8280364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pPr marL="0" marR="0" algn="ctr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I1-F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GAATCGAAGGAGTTTGCC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078708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I1-R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CTTAAGGTGATAATCTCTTTTACTT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93874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pPr marL="0" marR="0" algn="ctr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I2-F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TAAGCGGGCCTCTTAGCG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502659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RbohI2-R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1" hangingPunct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GATGTTCTGAACCGAA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3271398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RD19-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GGAGCACAATTACAGGTTC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9122164"/>
                  </a:ext>
                </a:extLst>
              </a:tr>
              <a:tr h="56747">
                <a:tc vMerge="1">
                  <a:txBody>
                    <a:bodyPr/>
                    <a:lstStyle/>
                    <a:p>
                      <a:pPr marL="0" marR="0" algn="ctr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RD19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CAAAACCTTATTCCGGAAC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946490"/>
                  </a:ext>
                </a:extLst>
              </a:tr>
              <a:tr h="7968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UBQ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AGGACTCTCAAGTTGACC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755338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UBQ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CCACATCGAGACTCAATA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4421156"/>
                  </a:ext>
                </a:extLst>
              </a:tr>
              <a:tr h="22513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Tubulin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AGGACTCTCAAGTTGACC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4054172"/>
                  </a:ext>
                </a:extLst>
              </a:tr>
              <a:tr h="2526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GmTubulin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CCACATCGAGACTCAATA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0865221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pPr marL="0" marR="0" algn="ctr" fontAlgn="ctr" latinLnBrk="1">
                        <a:lnSpc>
                          <a:spcPts val="126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Actin-F</a:t>
                      </a:r>
                    </a:p>
                  </a:txBody>
                  <a:tcPr marL="7596" marR="7596" marT="6963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TCCTTTCAGGAGGTACAACCAT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6146350"/>
                  </a:ext>
                </a:extLst>
              </a:tr>
              <a:tr h="2116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  <a:cs typeface="Times New Roman" panose="02020603050405020304" pitchFamily="18" charset="0"/>
                        </a:rPr>
                        <a:t>GmActin-R</a:t>
                      </a:r>
                    </a:p>
                  </a:txBody>
                  <a:tcPr marL="7596" marR="7596" marT="69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 latinLnBrk="1">
                        <a:lnSpc>
                          <a:spcPts val="1205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TGCTTAGAGATGCAAGGATTGA</a:t>
                      </a:r>
                    </a:p>
                  </a:txBody>
                  <a:tcPr marL="7596" marR="7596" marT="69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777171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51876CF-3D13-BC36-7801-F418512AE42C}"/>
              </a:ext>
            </a:extLst>
          </p:cNvPr>
          <p:cNvSpPr txBox="1"/>
          <p:nvPr/>
        </p:nvSpPr>
        <p:spPr>
          <a:xfrm>
            <a:off x="361031" y="2976273"/>
            <a:ext cx="43910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1. List of primers in this stud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36784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074D606-2B4F-1972-E0DE-AD744D59C865}"/>
              </a:ext>
            </a:extLst>
          </p:cNvPr>
          <p:cNvSpPr txBox="1"/>
          <p:nvPr/>
        </p:nvSpPr>
        <p:spPr>
          <a:xfrm>
            <a:off x="543698" y="1184440"/>
            <a:ext cx="6005383" cy="3483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l method</a:t>
            </a:r>
            <a:endParaRPr lang="en-US" sz="14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vitro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nase assay</a:t>
            </a:r>
            <a:endParaRPr lang="en-US" sz="12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NA fragments coding for GmMPK3, 6, 10 and GMKK1 were subcloned int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BAD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/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io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TOPO vector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rmoFisher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cientific).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ansformants containing these constructs were induced using 0.02 % Arabinose for 4 h [2], and the His-tagged fusion proteins were purified on Ni-NTA column as described by the manufacturer (Qiagen).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nase assays, protein fractions were prepared and aliquoted to 1.0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 protein/sample and brought to a total volume of 27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 with the grinding buffer.  To initiate the kinase reaction, 3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 of a solution containing 1 mg/mL myelin basic protein (MBP), 100 mM MgCl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100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ATP, and 1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i/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‑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2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-ATP (final concentrations of 100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/mL, 10 mM, 10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 ATP and 0.1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i/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, respectively) was added to each sample.  The phosphorylation reaction was allowed to proceed for 30 min at 23 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then was stopped by addition of 30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 of boiling 2x SDS sample buffer containing 100 mM dithiothreitol. 45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 of each sample was analyzed by SDS-PAGE on a 12.5%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aemmli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olyacrylamide gel, stained with Coomassie Blue,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stained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Phosphorylation of the substrate was analyzed by autoradiography and quantitated with a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hosphoimager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0883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71</TotalTime>
  <Words>1127</Words>
  <Application>Microsoft Office PowerPoint</Application>
  <PresentationFormat>A4 Paper (210x297 mm)</PresentationFormat>
  <Paragraphs>170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, JongHee</dc:creator>
  <cp:lastModifiedBy>Im, JongHee</cp:lastModifiedBy>
  <cp:revision>97</cp:revision>
  <dcterms:created xsi:type="dcterms:W3CDTF">2022-07-15T02:13:01Z</dcterms:created>
  <dcterms:modified xsi:type="dcterms:W3CDTF">2023-02-22T12:55:47Z</dcterms:modified>
</cp:coreProperties>
</file>